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C34B497-99AD-43FC-B226-85993102E037}" v="2" dt="2022-02-04T15:06:08.922"/>
    <p1510:client id="{419F9D42-3ECE-4798-AB8B-1FE9007012DD}" v="1" dt="2022-02-04T15:50:31.028"/>
    <p1510:client id="{985A5177-0E92-4312-BE7C-6CA2DCABE349}" v="2" dt="2022-02-04T15:49:39.56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792" autoAdjust="0"/>
  </p:normalViewPr>
  <p:slideViewPr>
    <p:cSldViewPr snapToGrid="0">
      <p:cViewPr varScale="1">
        <p:scale>
          <a:sx n="59" d="100"/>
          <a:sy n="59" d="100"/>
        </p:scale>
        <p:origin x="86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71BB16-2171-4DF8-B0E1-0806B6119696}" type="datetimeFigureOut">
              <a:rPr lang="en-US" smtClean="0"/>
              <a:t>2/4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DBE5BAC-CA5B-4D48-8A25-4E7DFC0FE9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84226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DBE5BAC-CA5B-4D48-8A25-4E7DFC0FE90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898578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AE6B1D-D004-444D-B721-32164EFFE09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5A7DEB0-246A-4AD4-BE68-8411ED2B360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BD84FF-1C46-4896-9795-FCAD187235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CF729-DD08-4C6B-9299-B6A734CC79A8}" type="datetimeFigureOut">
              <a:rPr lang="en-US" smtClean="0"/>
              <a:t>2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EBB916-9E45-4ED1-9670-E7EDA6302A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BF178D-64A9-427B-84EB-88D86036B4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F03B0-06A3-45D1-8942-517A34B3D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85674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4A7292-0BC8-410C-B0AA-019947FF23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D82A567-BE74-443C-99FC-C62336EE58F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CB1575-FCA8-456B-B5EA-BA5964DFE0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CF729-DD08-4C6B-9299-B6A734CC79A8}" type="datetimeFigureOut">
              <a:rPr lang="en-US" smtClean="0"/>
              <a:t>2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D684AD-04A7-4A36-9254-7C90F5153D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097393-28A7-4923-9ACA-53B3E2C880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F03B0-06A3-45D1-8942-517A34B3D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7153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89B44CA-988C-42EA-A5FA-98452DB2F83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83539FD-B98D-4FC9-ACDC-C8699203ED8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787C83-D1CB-4FE8-AB15-A270B8DD67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CF729-DD08-4C6B-9299-B6A734CC79A8}" type="datetimeFigureOut">
              <a:rPr lang="en-US" smtClean="0"/>
              <a:t>2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49D6B2-6DE0-4FA6-8BB9-4BB85BD09E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53BC50-6030-4307-988D-C60DCF324A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F03B0-06A3-45D1-8942-517A34B3D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95062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583E86-735F-4629-95A1-DDCC845EC6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058741A-7744-41B4-834C-6AB877A7928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A9072B-DC3F-4D43-8706-F132F85D7E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CF729-DD08-4C6B-9299-B6A734CC79A8}" type="datetimeFigureOut">
              <a:rPr lang="en-US" smtClean="0"/>
              <a:t>2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08F87A-B2EE-43B7-99E5-DD542AB7C7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39DFB1-D2DF-4201-BBF3-E483E18B4B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F03B0-06A3-45D1-8942-517A34B3D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19003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5FEE11-F89D-493D-8813-8EC99C628C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32DB6AC-9F97-41C7-A23A-15498AE881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072A82-A85A-4540-AC77-3BD025AA44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CF729-DD08-4C6B-9299-B6A734CC79A8}" type="datetimeFigureOut">
              <a:rPr lang="en-US" smtClean="0"/>
              <a:t>2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F7AA65-0F6D-41C4-BB4A-2888D35B74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ECC985-B2FA-4927-855E-AA4368CA9D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F03B0-06A3-45D1-8942-517A34B3D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71291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B21664-F23C-4939-9226-252FCF18CF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54C1EBC-B6D1-4FCD-ACBF-1AEA02FD0B1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D18431C-BABD-4584-8278-FD00DC31E8C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7465466-0F3D-449A-99D3-CB853223C6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CF729-DD08-4C6B-9299-B6A734CC79A8}" type="datetimeFigureOut">
              <a:rPr lang="en-US" smtClean="0"/>
              <a:t>2/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AFE0044-4BE2-4BFC-B509-3F5DAFD033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BA3A45A-26E1-4E3C-AAB3-788B1C5F20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F03B0-06A3-45D1-8942-517A34B3D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85924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C915FF-7A71-43CB-AD9F-964889CFC4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2DA8CD5-AE56-403D-80A6-95C372EF54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AFDC9F8-603C-4E57-925E-A0AA86470D5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E2258A1-4B4C-4065-B273-4ABDB3A7100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A147358-C74F-4D38-91AF-4E69A02A208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709FD07-EE57-4FF8-8A41-9CCDEBE58F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CF729-DD08-4C6B-9299-B6A734CC79A8}" type="datetimeFigureOut">
              <a:rPr lang="en-US" smtClean="0"/>
              <a:t>2/4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5EB95D8-9FE3-40E2-8205-CED50C2905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99E7F8D-1B25-45F5-9B16-5A35EADDE3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F03B0-06A3-45D1-8942-517A34B3D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87043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B751A1-5012-48A2-B362-FC12C37F24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C0F9217-8FD6-493F-ADEE-9B275D8CC1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CF729-DD08-4C6B-9299-B6A734CC79A8}" type="datetimeFigureOut">
              <a:rPr lang="en-US" smtClean="0"/>
              <a:t>2/4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3ED7633-1B94-4BBE-891A-4B88681070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FBE4EED-CCEF-445B-AC29-15773A69F5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F03B0-06A3-45D1-8942-517A34B3D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24905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F8832C5-469F-489A-A426-6459BBB4D4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CF729-DD08-4C6B-9299-B6A734CC79A8}" type="datetimeFigureOut">
              <a:rPr lang="en-US" smtClean="0"/>
              <a:t>2/4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5856A43-E6D7-424F-BC98-54268399CF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504E9EE-4DE5-4415-810A-9719F747DF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F03B0-06A3-45D1-8942-517A34B3D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77056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74659B-B83E-43A9-864A-DEC85611A0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6A79C3-C314-485A-BA77-1A6A06F9F5E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EC6167A-C484-4CC4-AA9F-822C6BEF39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72C3632-F514-4B08-94BA-EC5184C628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CF729-DD08-4C6B-9299-B6A734CC79A8}" type="datetimeFigureOut">
              <a:rPr lang="en-US" smtClean="0"/>
              <a:t>2/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BA25D0D-BEEC-4BC3-8B99-90773F4B6A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7993707-A169-46FA-B3AC-AE62B5C78D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F03B0-06A3-45D1-8942-517A34B3D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32726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E9405A-3897-4F98-BFB5-FDB18CFEEF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22D41CA-AC57-4032-B8D4-D917FCD70B4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AE4F17B-F86F-4DBF-8AA4-0D61FF5F824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10AA271-ECB9-4D03-BF8A-167BA52F99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CF729-DD08-4C6B-9299-B6A734CC79A8}" type="datetimeFigureOut">
              <a:rPr lang="en-US" smtClean="0"/>
              <a:t>2/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9649B06-0770-47DC-A50C-C4789D781D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4DD0223-3CDD-44AC-B8CC-2FDE235777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F03B0-06A3-45D1-8942-517A34B3D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78474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9095110-4707-4DEE-B646-FCF4B08379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E43593C-C865-4525-941C-30AE55DA34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E0B3BD-6AF7-41A8-91F0-B93E7440FCF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5CF729-DD08-4C6B-9299-B6A734CC79A8}" type="datetimeFigureOut">
              <a:rPr lang="en-US" smtClean="0"/>
              <a:t>2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F6F719-504E-41F3-BBC5-56A692A408F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F2F38C-F370-411F-93DE-64BF5826C67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DF03B0-06A3-45D1-8942-517A34B3D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04003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28A71E9C-5BDD-4E56-B8A9-0579D3008011}"/>
              </a:ext>
            </a:extLst>
          </p:cNvPr>
          <p:cNvSpPr txBox="1"/>
          <p:nvPr/>
        </p:nvSpPr>
        <p:spPr>
          <a:xfrm>
            <a:off x="1850571" y="5421085"/>
            <a:ext cx="8490857" cy="129439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2.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hromosomal distribution of peaks detected by MACS2 (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q-value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&lt; 0.05) in weaning. BW: before weaning; AW: after weaning. Each condition has two biological replicates.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AF5F0A5-7FA1-43E0-BB41-450009211B0E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52600" y="522514"/>
            <a:ext cx="7815942" cy="4898571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3759967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6</Words>
  <Application>Microsoft Office PowerPoint</Application>
  <PresentationFormat>Widescreen</PresentationFormat>
  <Paragraphs>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/>
  <cp:revision>1</cp:revision>
  <dcterms:created xsi:type="dcterms:W3CDTF">2022-02-04T15:06:08Z</dcterms:created>
  <dcterms:modified xsi:type="dcterms:W3CDTF">2022-02-04T15:50:59Z</dcterms:modified>
</cp:coreProperties>
</file>